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572" r:id="rId5"/>
    <p:sldId id="574" r:id="rId6"/>
    <p:sldId id="577" r:id="rId7"/>
    <p:sldId id="570" r:id="rId8"/>
    <p:sldId id="575" r:id="rId9"/>
    <p:sldId id="576" r:id="rId10"/>
  </p:sldIdLst>
  <p:sldSz cx="12192000" cy="6858000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 Files" id="{5B9F8EE5-C506-4D08-8A3A-D879B16F64A2}">
          <p14:sldIdLst>
            <p14:sldId id="572"/>
            <p14:sldId id="574"/>
            <p14:sldId id="577"/>
            <p14:sldId id="570"/>
            <p14:sldId id="575"/>
            <p14:sldId id="57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592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B69E29-995F-FCD6-CBE0-731F848C90E4}" name="Wilkins, Kenneth (NIH/NIDDK) [E]" initials="W[" userId="S::wilkinskj@nih.gov::d47b69af-d684-4df6-9e82-5b1ab23716e1" providerId="AD"/>
  <p188:author id="{6CC1CC5C-20A8-34DE-FF2F-CDB54047AC54}" name="Ebenuwa, Ifechukwude (NIH/NIDDK) [E]" initials="EI([" userId="S::ebenuwaic@nih.gov::69f1105d-2808-4f7e-9260-1173d3e9bcfb" providerId="AD"/>
  <p188:author id="{5D32CF8E-87D4-646A-BAFE-C12BE97626C7}" name="Violet, Pierre-Christian (NIH/NIDDK) [E]" initials="VPC([" userId="S::violetp@nih.gov::93a7ce0d-0092-46af-a322-90a34025d65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388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701C8D7-5729-4883-9488-1C93F15E6E00}" v="7" dt="2024-09-20T11:56:49.044"/>
  </p1510:revLst>
</p1510:revInfo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678" y="102"/>
      </p:cViewPr>
      <p:guideLst>
        <p:guide orient="horz" pos="259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benuwa, Ifechukwude (NIH/NIDDK) [E]" userId="69f1105d-2808-4f7e-9260-1173d3e9bcfb" providerId="ADAL" clId="{8701C8D7-5729-4883-9488-1C93F15E6E00}"/>
    <pc:docChg chg="undo custSel delSld modSld modSection">
      <pc:chgData name="Ebenuwa, Ifechukwude (NIH/NIDDK) [E]" userId="69f1105d-2808-4f7e-9260-1173d3e9bcfb" providerId="ADAL" clId="{8701C8D7-5729-4883-9488-1C93F15E6E00}" dt="2024-09-20T22:01:24.288" v="1166" actId="20577"/>
      <pc:docMkLst>
        <pc:docMk/>
      </pc:docMkLst>
      <pc:sldChg chg="addSp delSp modSp mod">
        <pc:chgData name="Ebenuwa, Ifechukwude (NIH/NIDDK) [E]" userId="69f1105d-2808-4f7e-9260-1173d3e9bcfb" providerId="ADAL" clId="{8701C8D7-5729-4883-9488-1C93F15E6E00}" dt="2024-09-20T13:12:57.770" v="1162" actId="20577"/>
        <pc:sldMkLst>
          <pc:docMk/>
          <pc:sldMk cId="1119959291" sldId="570"/>
        </pc:sldMkLst>
        <pc:spChg chg="mod">
          <ac:chgData name="Ebenuwa, Ifechukwude (NIH/NIDDK) [E]" userId="69f1105d-2808-4f7e-9260-1173d3e9bcfb" providerId="ADAL" clId="{8701C8D7-5729-4883-9488-1C93F15E6E00}" dt="2024-09-20T13:06:18.532" v="1041" actId="1076"/>
          <ac:spMkLst>
            <pc:docMk/>
            <pc:sldMk cId="1119959291" sldId="570"/>
            <ac:spMk id="2" creationId="{95EBB9DE-E77D-9898-AFE2-A238DE725E70}"/>
          </ac:spMkLst>
        </pc:spChg>
        <pc:spChg chg="add del mod">
          <ac:chgData name="Ebenuwa, Ifechukwude (NIH/NIDDK) [E]" userId="69f1105d-2808-4f7e-9260-1173d3e9bcfb" providerId="ADAL" clId="{8701C8D7-5729-4883-9488-1C93F15E6E00}" dt="2024-09-20T13:06:23.223" v="1042" actId="1076"/>
          <ac:spMkLst>
            <pc:docMk/>
            <pc:sldMk cId="1119959291" sldId="570"/>
            <ac:spMk id="3" creationId="{80FEEC0C-261F-1B09-103F-EFE5155D512E}"/>
          </ac:spMkLst>
        </pc:spChg>
        <pc:spChg chg="mod">
          <ac:chgData name="Ebenuwa, Ifechukwude (NIH/NIDDK) [E]" userId="69f1105d-2808-4f7e-9260-1173d3e9bcfb" providerId="ADAL" clId="{8701C8D7-5729-4883-9488-1C93F15E6E00}" dt="2024-09-20T13:12:57.770" v="1162" actId="20577"/>
          <ac:spMkLst>
            <pc:docMk/>
            <pc:sldMk cId="1119959291" sldId="570"/>
            <ac:spMk id="7" creationId="{3F2A3B5F-487F-33C1-CDF7-E75FFA6F70FA}"/>
          </ac:spMkLst>
        </pc:spChg>
        <pc:spChg chg="mod">
          <ac:chgData name="Ebenuwa, Ifechukwude (NIH/NIDDK) [E]" userId="69f1105d-2808-4f7e-9260-1173d3e9bcfb" providerId="ADAL" clId="{8701C8D7-5729-4883-9488-1C93F15E6E00}" dt="2024-09-20T13:09:26.310" v="1058" actId="20577"/>
          <ac:spMkLst>
            <pc:docMk/>
            <pc:sldMk cId="1119959291" sldId="570"/>
            <ac:spMk id="34" creationId="{9CEB9ADE-E2F4-7C7F-168F-0275A943A0AF}"/>
          </ac:spMkLst>
        </pc:spChg>
        <pc:spChg chg="mod">
          <ac:chgData name="Ebenuwa, Ifechukwude (NIH/NIDDK) [E]" userId="69f1105d-2808-4f7e-9260-1173d3e9bcfb" providerId="ADAL" clId="{8701C8D7-5729-4883-9488-1C93F15E6E00}" dt="2024-09-20T13:06:13.052" v="1040" actId="1076"/>
          <ac:spMkLst>
            <pc:docMk/>
            <pc:sldMk cId="1119959291" sldId="570"/>
            <ac:spMk id="43" creationId="{C3B56DD9-8604-8F09-4025-90207F6943F8}"/>
          </ac:spMkLst>
        </pc:spChg>
        <pc:picChg chg="mod">
          <ac:chgData name="Ebenuwa, Ifechukwude (NIH/NIDDK) [E]" userId="69f1105d-2808-4f7e-9260-1173d3e9bcfb" providerId="ADAL" clId="{8701C8D7-5729-4883-9488-1C93F15E6E00}" dt="2024-09-20T13:06:03.671" v="1038" actId="1076"/>
          <ac:picMkLst>
            <pc:docMk/>
            <pc:sldMk cId="1119959291" sldId="570"/>
            <ac:picMk id="29" creationId="{B0641B85-841C-24A6-7ADD-EDDA569324C5}"/>
          </ac:picMkLst>
        </pc:picChg>
        <pc:picChg chg="mod">
          <ac:chgData name="Ebenuwa, Ifechukwude (NIH/NIDDK) [E]" userId="69f1105d-2808-4f7e-9260-1173d3e9bcfb" providerId="ADAL" clId="{8701C8D7-5729-4883-9488-1C93F15E6E00}" dt="2024-09-20T13:06:07.903" v="1039" actId="1076"/>
          <ac:picMkLst>
            <pc:docMk/>
            <pc:sldMk cId="1119959291" sldId="570"/>
            <ac:picMk id="31" creationId="{701C5F41-12B1-EA4C-BE24-77DA800E0A0F}"/>
          </ac:picMkLst>
        </pc:picChg>
        <pc:picChg chg="mod">
          <ac:chgData name="Ebenuwa, Ifechukwude (NIH/NIDDK) [E]" userId="69f1105d-2808-4f7e-9260-1173d3e9bcfb" providerId="ADAL" clId="{8701C8D7-5729-4883-9488-1C93F15E6E00}" dt="2024-09-20T13:06:01.037" v="1037" actId="14100"/>
          <ac:picMkLst>
            <pc:docMk/>
            <pc:sldMk cId="1119959291" sldId="570"/>
            <ac:picMk id="33" creationId="{BC9641A4-2D44-B559-EF40-33DF352A7E38}"/>
          </ac:picMkLst>
        </pc:picChg>
      </pc:sldChg>
      <pc:sldChg chg="del">
        <pc:chgData name="Ebenuwa, Ifechukwude (NIH/NIDDK) [E]" userId="69f1105d-2808-4f7e-9260-1173d3e9bcfb" providerId="ADAL" clId="{8701C8D7-5729-4883-9488-1C93F15E6E00}" dt="2024-09-20T11:16:09.407" v="0" actId="2696"/>
        <pc:sldMkLst>
          <pc:docMk/>
          <pc:sldMk cId="4173535794" sldId="573"/>
        </pc:sldMkLst>
      </pc:sldChg>
      <pc:sldChg chg="modSp mod">
        <pc:chgData name="Ebenuwa, Ifechukwude (NIH/NIDDK) [E]" userId="69f1105d-2808-4f7e-9260-1173d3e9bcfb" providerId="ADAL" clId="{8701C8D7-5729-4883-9488-1C93F15E6E00}" dt="2024-09-20T13:13:53.627" v="1164" actId="20577"/>
        <pc:sldMkLst>
          <pc:docMk/>
          <pc:sldMk cId="3280845998" sldId="574"/>
        </pc:sldMkLst>
        <pc:spChg chg="mod">
          <ac:chgData name="Ebenuwa, Ifechukwude (NIH/NIDDK) [E]" userId="69f1105d-2808-4f7e-9260-1173d3e9bcfb" providerId="ADAL" clId="{8701C8D7-5729-4883-9488-1C93F15E6E00}" dt="2024-09-20T13:13:53.627" v="1164" actId="20577"/>
          <ac:spMkLst>
            <pc:docMk/>
            <pc:sldMk cId="3280845998" sldId="574"/>
            <ac:spMk id="3" creationId="{37ECF3F3-AA4B-0580-4E3D-2F68D70ED476}"/>
          </ac:spMkLst>
        </pc:spChg>
      </pc:sldChg>
      <pc:sldChg chg="modSp mod">
        <pc:chgData name="Ebenuwa, Ifechukwude (NIH/NIDDK) [E]" userId="69f1105d-2808-4f7e-9260-1173d3e9bcfb" providerId="ADAL" clId="{8701C8D7-5729-4883-9488-1C93F15E6E00}" dt="2024-09-20T12:06:55.694" v="550" actId="6549"/>
        <pc:sldMkLst>
          <pc:docMk/>
          <pc:sldMk cId="2221750322" sldId="576"/>
        </pc:sldMkLst>
        <pc:graphicFrameChg chg="mod modGraphic">
          <ac:chgData name="Ebenuwa, Ifechukwude (NIH/NIDDK) [E]" userId="69f1105d-2808-4f7e-9260-1173d3e9bcfb" providerId="ADAL" clId="{8701C8D7-5729-4883-9488-1C93F15E6E00}" dt="2024-09-20T11:56:45.117" v="311" actId="6549"/>
          <ac:graphicFrameMkLst>
            <pc:docMk/>
            <pc:sldMk cId="2221750322" sldId="576"/>
            <ac:graphicFrameMk id="6" creationId="{05AFE535-B3EF-B54F-D571-AA2583FA5843}"/>
          </ac:graphicFrameMkLst>
        </pc:graphicFrameChg>
        <pc:graphicFrameChg chg="mod modGraphic">
          <ac:chgData name="Ebenuwa, Ifechukwude (NIH/NIDDK) [E]" userId="69f1105d-2808-4f7e-9260-1173d3e9bcfb" providerId="ADAL" clId="{8701C8D7-5729-4883-9488-1C93F15E6E00}" dt="2024-09-20T12:06:55.694" v="550" actId="6549"/>
          <ac:graphicFrameMkLst>
            <pc:docMk/>
            <pc:sldMk cId="2221750322" sldId="576"/>
            <ac:graphicFrameMk id="7" creationId="{B904BBC8-0F28-03F0-41EE-2FC44080AAEA}"/>
          </ac:graphicFrameMkLst>
        </pc:graphicFrameChg>
      </pc:sldChg>
      <pc:sldChg chg="delSp modSp mod">
        <pc:chgData name="Ebenuwa, Ifechukwude (NIH/NIDDK) [E]" userId="69f1105d-2808-4f7e-9260-1173d3e9bcfb" providerId="ADAL" clId="{8701C8D7-5729-4883-9488-1C93F15E6E00}" dt="2024-09-20T22:01:24.288" v="1166" actId="20577"/>
        <pc:sldMkLst>
          <pc:docMk/>
          <pc:sldMk cId="1276912252" sldId="577"/>
        </pc:sldMkLst>
        <pc:spChg chg="mod">
          <ac:chgData name="Ebenuwa, Ifechukwude (NIH/NIDDK) [E]" userId="69f1105d-2808-4f7e-9260-1173d3e9bcfb" providerId="ADAL" clId="{8701C8D7-5729-4883-9488-1C93F15E6E00}" dt="2024-09-20T11:37:07.065" v="224" actId="1076"/>
          <ac:spMkLst>
            <pc:docMk/>
            <pc:sldMk cId="1276912252" sldId="577"/>
            <ac:spMk id="10" creationId="{16B6C636-A3C4-5173-FD84-D76AE2B0734A}"/>
          </ac:spMkLst>
        </pc:spChg>
        <pc:spChg chg="mod">
          <ac:chgData name="Ebenuwa, Ifechukwude (NIH/NIDDK) [E]" userId="69f1105d-2808-4f7e-9260-1173d3e9bcfb" providerId="ADAL" clId="{8701C8D7-5729-4883-9488-1C93F15E6E00}" dt="2024-09-20T13:11:08.849" v="1060" actId="20577"/>
          <ac:spMkLst>
            <pc:docMk/>
            <pc:sldMk cId="1276912252" sldId="577"/>
            <ac:spMk id="12" creationId="{FEBBFB41-C6E7-A938-AEFB-CECEFFF0EBEE}"/>
          </ac:spMkLst>
        </pc:spChg>
        <pc:spChg chg="mod">
          <ac:chgData name="Ebenuwa, Ifechukwude (NIH/NIDDK) [E]" userId="69f1105d-2808-4f7e-9260-1173d3e9bcfb" providerId="ADAL" clId="{8701C8D7-5729-4883-9488-1C93F15E6E00}" dt="2024-09-20T11:37:12.161" v="225" actId="1076"/>
          <ac:spMkLst>
            <pc:docMk/>
            <pc:sldMk cId="1276912252" sldId="577"/>
            <ac:spMk id="13" creationId="{1A0E0FD1-32A5-0C57-81A8-FAA5BC94B32F}"/>
          </ac:spMkLst>
        </pc:spChg>
        <pc:spChg chg="del">
          <ac:chgData name="Ebenuwa, Ifechukwude (NIH/NIDDK) [E]" userId="69f1105d-2808-4f7e-9260-1173d3e9bcfb" providerId="ADAL" clId="{8701C8D7-5729-4883-9488-1C93F15E6E00}" dt="2024-09-20T11:18:57.677" v="29" actId="21"/>
          <ac:spMkLst>
            <pc:docMk/>
            <pc:sldMk cId="1276912252" sldId="577"/>
            <ac:spMk id="15" creationId="{2CD5E13D-A2E6-63C3-8ED6-3723199C7753}"/>
          </ac:spMkLst>
        </pc:spChg>
        <pc:spChg chg="mod">
          <ac:chgData name="Ebenuwa, Ifechukwude (NIH/NIDDK) [E]" userId="69f1105d-2808-4f7e-9260-1173d3e9bcfb" providerId="ADAL" clId="{8701C8D7-5729-4883-9488-1C93F15E6E00}" dt="2024-09-20T11:37:16.111" v="226" actId="1076"/>
          <ac:spMkLst>
            <pc:docMk/>
            <pc:sldMk cId="1276912252" sldId="577"/>
            <ac:spMk id="16" creationId="{30414CE3-901F-676B-AD6F-28270791524F}"/>
          </ac:spMkLst>
        </pc:spChg>
        <pc:spChg chg="mod">
          <ac:chgData name="Ebenuwa, Ifechukwude (NIH/NIDDK) [E]" userId="69f1105d-2808-4f7e-9260-1173d3e9bcfb" providerId="ADAL" clId="{8701C8D7-5729-4883-9488-1C93F15E6E00}" dt="2024-09-20T22:01:24.288" v="1166" actId="20577"/>
          <ac:spMkLst>
            <pc:docMk/>
            <pc:sldMk cId="1276912252" sldId="577"/>
            <ac:spMk id="19" creationId="{8C3899AE-C396-1692-F693-640B58BAEB04}"/>
          </ac:spMkLst>
        </pc:spChg>
        <pc:spChg chg="mod">
          <ac:chgData name="Ebenuwa, Ifechukwude (NIH/NIDDK) [E]" userId="69f1105d-2808-4f7e-9260-1173d3e9bcfb" providerId="ADAL" clId="{8701C8D7-5729-4883-9488-1C93F15E6E00}" dt="2024-09-20T11:18:42.377" v="24" actId="1076"/>
          <ac:spMkLst>
            <pc:docMk/>
            <pc:sldMk cId="1276912252" sldId="577"/>
            <ac:spMk id="1031" creationId="{118F37BE-7487-0AC7-14BD-8AC0E8E2D57A}"/>
          </ac:spMkLst>
        </pc:spChg>
        <pc:spChg chg="mod">
          <ac:chgData name="Ebenuwa, Ifechukwude (NIH/NIDDK) [E]" userId="69f1105d-2808-4f7e-9260-1173d3e9bcfb" providerId="ADAL" clId="{8701C8D7-5729-4883-9488-1C93F15E6E00}" dt="2024-09-20T11:18:46.425" v="25" actId="1076"/>
          <ac:spMkLst>
            <pc:docMk/>
            <pc:sldMk cId="1276912252" sldId="577"/>
            <ac:spMk id="1032" creationId="{BFD8A151-F263-2451-7BE5-5EF0BD5007B3}"/>
          </ac:spMkLst>
        </pc:spChg>
        <pc:spChg chg="del">
          <ac:chgData name="Ebenuwa, Ifechukwude (NIH/NIDDK) [E]" userId="69f1105d-2808-4f7e-9260-1173d3e9bcfb" providerId="ADAL" clId="{8701C8D7-5729-4883-9488-1C93F15E6E00}" dt="2024-09-20T11:18:10.520" v="17" actId="21"/>
          <ac:spMkLst>
            <pc:docMk/>
            <pc:sldMk cId="1276912252" sldId="577"/>
            <ac:spMk id="1053" creationId="{415014E3-7DB0-55C6-79B1-F1FBB6ACC72D}"/>
          </ac:spMkLst>
        </pc:spChg>
        <pc:graphicFrameChg chg="mod">
          <ac:chgData name="Ebenuwa, Ifechukwude (NIH/NIDDK) [E]" userId="69f1105d-2808-4f7e-9260-1173d3e9bcfb" providerId="ADAL" clId="{8701C8D7-5729-4883-9488-1C93F15E6E00}" dt="2024-09-20T11:19:07.200" v="31" actId="1076"/>
          <ac:graphicFrameMkLst>
            <pc:docMk/>
            <pc:sldMk cId="1276912252" sldId="577"/>
            <ac:graphicFrameMk id="4" creationId="{48AAA4EE-5844-CA73-344A-BCC758EA29A2}"/>
          </ac:graphicFrameMkLst>
        </pc:graphicFrameChg>
        <pc:picChg chg="del">
          <ac:chgData name="Ebenuwa, Ifechukwude (NIH/NIDDK) [E]" userId="69f1105d-2808-4f7e-9260-1173d3e9bcfb" providerId="ADAL" clId="{8701C8D7-5729-4883-9488-1C93F15E6E00}" dt="2024-09-20T11:18:07.241" v="16" actId="21"/>
          <ac:picMkLst>
            <pc:docMk/>
            <pc:sldMk cId="1276912252" sldId="577"/>
            <ac:picMk id="1024" creationId="{A0E3CFB3-6248-6ACA-865B-D5F452E19EA2}"/>
          </ac:picMkLst>
        </pc:picChg>
        <pc:picChg chg="mod">
          <ac:chgData name="Ebenuwa, Ifechukwude (NIH/NIDDK) [E]" userId="69f1105d-2808-4f7e-9260-1173d3e9bcfb" providerId="ADAL" clId="{8701C8D7-5729-4883-9488-1C93F15E6E00}" dt="2024-09-20T11:18:19.967" v="19" actId="1076"/>
          <ac:picMkLst>
            <pc:docMk/>
            <pc:sldMk cId="1276912252" sldId="577"/>
            <ac:picMk id="1034" creationId="{0542FE44-6B46-641F-9BA5-15B37D458D30}"/>
          </ac:picMkLst>
        </pc:picChg>
        <pc:cxnChg chg="mod">
          <ac:chgData name="Ebenuwa, Ifechukwude (NIH/NIDDK) [E]" userId="69f1105d-2808-4f7e-9260-1173d3e9bcfb" providerId="ADAL" clId="{8701C8D7-5729-4883-9488-1C93F15E6E00}" dt="2024-09-20T11:18:29.300" v="21" actId="1076"/>
          <ac:cxnSpMkLst>
            <pc:docMk/>
            <pc:sldMk cId="1276912252" sldId="577"/>
            <ac:cxnSpMk id="1029" creationId="{1C70D4F4-4BA7-6E1A-E45B-A9A24F257D40}"/>
          </ac:cxnSpMkLst>
        </pc:cxnChg>
        <pc:cxnChg chg="mod">
          <ac:chgData name="Ebenuwa, Ifechukwude (NIH/NIDDK) [E]" userId="69f1105d-2808-4f7e-9260-1173d3e9bcfb" providerId="ADAL" clId="{8701C8D7-5729-4883-9488-1C93F15E6E00}" dt="2024-09-20T11:18:37.305" v="23" actId="1076"/>
          <ac:cxnSpMkLst>
            <pc:docMk/>
            <pc:sldMk cId="1276912252" sldId="577"/>
            <ac:cxnSpMk id="1030" creationId="{E5F6D749-7EDC-C5DF-6956-A1738A20F5BA}"/>
          </ac:cxnSpMkLst>
        </pc:cxnChg>
        <pc:cxnChg chg="del">
          <ac:chgData name="Ebenuwa, Ifechukwude (NIH/NIDDK) [E]" userId="69f1105d-2808-4f7e-9260-1173d3e9bcfb" providerId="ADAL" clId="{8701C8D7-5729-4883-9488-1C93F15E6E00}" dt="2024-09-20T11:18:13.557" v="18" actId="21"/>
          <ac:cxnSpMkLst>
            <pc:docMk/>
            <pc:sldMk cId="1276912252" sldId="577"/>
            <ac:cxnSpMk id="1052" creationId="{C5A2EB21-927A-F59D-1132-3DF063D8137D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11488" cy="463550"/>
          </a:xfrm>
          <a:prstGeom prst="rect">
            <a:avLst/>
          </a:prstGeom>
        </p:spPr>
        <p:txBody>
          <a:bodyPr vert="horz" lIns="91436" tIns="45718" rIns="91436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7000" y="1"/>
            <a:ext cx="3011488" cy="463550"/>
          </a:xfrm>
          <a:prstGeom prst="rect">
            <a:avLst/>
          </a:prstGeom>
        </p:spPr>
        <p:txBody>
          <a:bodyPr vert="horz" lIns="91436" tIns="45718" rIns="91436" bIns="45718" rtlCol="0"/>
          <a:lstStyle>
            <a:lvl1pPr algn="r">
              <a:defRPr sz="1200"/>
            </a:lvl1pPr>
          </a:lstStyle>
          <a:p>
            <a:fld id="{C2DB092A-754E-4212-BB69-014499CE4756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04850" y="1154113"/>
            <a:ext cx="5540375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6" tIns="45718" rIns="91436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6" y="4445001"/>
            <a:ext cx="5559425" cy="3636963"/>
          </a:xfrm>
          <a:prstGeom prst="rect">
            <a:avLst/>
          </a:prstGeom>
        </p:spPr>
        <p:txBody>
          <a:bodyPr vert="horz" lIns="91436" tIns="45718" rIns="91436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525"/>
            <a:ext cx="3011488" cy="463550"/>
          </a:xfrm>
          <a:prstGeom prst="rect">
            <a:avLst/>
          </a:prstGeom>
        </p:spPr>
        <p:txBody>
          <a:bodyPr vert="horz" lIns="91436" tIns="45718" rIns="91436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7000" y="8772525"/>
            <a:ext cx="3011488" cy="463550"/>
          </a:xfrm>
          <a:prstGeom prst="rect">
            <a:avLst/>
          </a:prstGeom>
        </p:spPr>
        <p:txBody>
          <a:bodyPr vert="horz" lIns="91436" tIns="45718" rIns="91436" bIns="45718" rtlCol="0" anchor="b"/>
          <a:lstStyle>
            <a:lvl1pPr algn="r">
              <a:defRPr sz="1200"/>
            </a:lvl1pPr>
          </a:lstStyle>
          <a:p>
            <a:fld id="{DA7AD2BF-6A06-4A54-BF04-661C5692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7452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7AD2BF-6A06-4A54-BF04-661C5692E3C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0250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7AD2BF-6A06-4A54-BF04-661C5692E3C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776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BA339-71B6-4691-418C-A622496F56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795912E-F2B3-7EB2-C9CD-A02FF5F49A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F42FCF-A6C8-BFA2-30BA-82B754DA4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AD3DFE-1343-3966-581E-74F1A3BD9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CB2256-E705-F47E-59DB-C7351ADDE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942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E038E-2FCE-2C1F-72B3-873EF52F78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8CF882-2635-CEB8-EA0F-50AF015323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FF9573-1016-DA73-84D2-10A2A51D4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65066C-0EB7-5D07-32D5-0EF52276A0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5DF101-3F48-93B2-01CA-B441861CB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165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52BB8A-8F2F-956F-CF7B-2C01966B35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6C308A-2FF4-62AE-DE75-4666DCB360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538822-841F-89D5-DEA8-C11F96A7D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2A5F57-E4E1-B50F-EBEF-EEEA40037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06028-EEFB-843C-767D-64C6814B1B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246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6D168A-4130-B950-4BCB-EC4853D010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16B714-F05D-3064-3003-9B756274EC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2893DF-6A93-FAF1-9651-B0BDA1B97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268CB9-E4AA-AF5D-2EB2-2826812F4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6A221-1EEA-D163-B9AE-F5E57DC3C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13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3C81A6-AD7C-03B7-4898-37C3D5491F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250917-949C-D205-64CC-A7552B1971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E8018E-AB47-1442-3450-F6E2845E3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3157AD-9F66-DFC0-0A07-A52BDC07B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0D6A72-84F8-3B04-4D19-355328FFB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292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32869D-5EA7-71D7-CB74-0540238A90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3AED4-51DE-DB6D-E816-7439160D91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EC38E0-7AF8-E9B1-F188-3970B79027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7606C8-60FD-D817-2DF0-EF991F56C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15EC1E-C170-578E-D55E-6CE96E326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C7EBCE-5353-31A0-E399-B610DFE0B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535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FD11CD-DF17-7B44-1521-29125934E7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C665D8-7F80-B8E0-6DB8-5073E5EBC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67641B-EAF5-DE6D-5CAA-8644195E82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FC0690-D6BC-FABC-CEF8-EFFE772101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26B03E-9DB4-FA5A-DB78-3A3FDF76D7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23B3F7-333B-AE87-462E-A987B6F31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A4BC35-6C27-2272-AB23-49B9CAC05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4F9457-E11C-7C00-C7D3-241F319C6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666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46BD67-1A49-81DE-B245-3586BF3974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C1A35F-7B36-0385-84F0-C85465FF7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C73CDC-A38E-9339-8A0D-A26127AC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A7091C-3AF1-89D5-AAB1-6E9070E27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251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12310F-3CA0-5D92-CE97-9EF5E62BB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F664447-4DB7-F350-267E-A4EB3BCA7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220AF6-1BDA-70FB-C3A0-5597F2548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438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6F0397-EA07-1660-1AED-AFD0C17BE0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BBEE88-EE1A-6CCA-3C11-C0FC1DFC5A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0186D3-158F-B65C-5179-E1970E9C3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BAD823-64CA-1EB2-7914-9A2FC5B7B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381418-2764-BBFC-6FD2-1D8943B4A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B11F96-664C-BD52-4A83-2CF620FB5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453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45896-5C39-CAD3-7006-BA8FC061C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43076D-ECCD-38B6-661F-4AAFE686F3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C7BE86-C603-7A61-5A5F-32C42CB925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ABE5DD-9C15-8DB5-830A-6CFFBFB7F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6D3171-3212-DDFF-41C8-E355F975D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0D94A6-1CEF-6ECE-9D64-53370BC30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730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7CF03D-7557-A914-A8F2-CE0FBA81BD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714640-91C8-EBA8-EE45-83CAD925F7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7FC81D-35DE-29EA-00CA-AF148F4A3F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A7800-16CC-4F7D-AC35-F892B49A3FE3}" type="datetimeFigureOut">
              <a:rPr lang="en-US" smtClean="0"/>
              <a:t>9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496F44-A6B8-122C-6239-BB94843C7B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9FD31E-2567-1F3E-F60E-AD60F35D45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6928E-567E-4E05-9525-3D9C95216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356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3FD8A89-ECD7-4AFE-A91B-DB9A9902CCBB}"/>
              </a:ext>
            </a:extLst>
          </p:cNvPr>
          <p:cNvSpPr txBox="1"/>
          <p:nvPr/>
        </p:nvSpPr>
        <p:spPr>
          <a:xfrm>
            <a:off x="0" y="-12303"/>
            <a:ext cx="12192000" cy="407804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1:  Derived shear stress-gradient RBCD measures in participants included from osmotic-gradient studies. </a:t>
            </a:r>
          </a:p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8714E6-0EA8-3DAE-1AEB-E4E080601C42}"/>
              </a:ext>
            </a:extLst>
          </p:cNvPr>
          <p:cNvSpPr txBox="1"/>
          <p:nvPr/>
        </p:nvSpPr>
        <p:spPr>
          <a:xfrm>
            <a:off x="135024" y="865282"/>
            <a:ext cx="5523822" cy="438582"/>
          </a:xfrm>
          <a:prstGeom prst="rect">
            <a:avLst/>
          </a:prstGeom>
          <a:noFill/>
        </p:spPr>
        <p:txBody>
          <a:bodyPr wrap="square" lIns="68580" tIns="34290" rIns="68580" bIns="3429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:  </a:t>
            </a:r>
            <a:r>
              <a:rPr kumimoji="0" lang="en-US" sz="1200" b="0" i="0" u="none" strike="noStrike" kern="1200" cap="none" spc="0" normalizeH="0" baseline="0" noProof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Imax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 the diabetes cohort (n=49) and nondiabetic controls (n=40) for participants included in osmotic gradient studies</a:t>
            </a:r>
            <a:endParaRPr kumimoji="0" lang="en-US" sz="12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Calibri" panose="020F0502020204030204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86FBB9C-C74F-55FE-E2C4-B0378B87904D}"/>
              </a:ext>
            </a:extLst>
          </p:cNvPr>
          <p:cNvSpPr txBox="1"/>
          <p:nvPr/>
        </p:nvSpPr>
        <p:spPr>
          <a:xfrm>
            <a:off x="5975386" y="852544"/>
            <a:ext cx="5523822" cy="438582"/>
          </a:xfrm>
          <a:prstGeom prst="rect">
            <a:avLst/>
          </a:prstGeom>
          <a:noFill/>
        </p:spPr>
        <p:txBody>
          <a:bodyPr wrap="square" lIns="68580" tIns="34290" rIns="68580" bIns="3429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:  SS</a:t>
            </a:r>
            <a:r>
              <a:rPr kumimoji="0" lang="en-US" sz="1200" b="0" i="0" u="none" strike="noStrike" kern="1200" cap="none" spc="0" normalizeH="0" baseline="-2500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/2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 the diabetes cohort (n=49) and nondiabetic controls (n=40) for participants included in osmotic gradient studies</a:t>
            </a:r>
            <a:endParaRPr kumimoji="0" lang="en-US" sz="12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Calibri" panose="020F0502020204030204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4DDE289-3BFF-0019-E3F7-A0F71D0995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8400" y="1594281"/>
            <a:ext cx="3256020" cy="238024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8F508D4-39ED-35F6-B01F-559C5E9ACBF1}"/>
              </a:ext>
            </a:extLst>
          </p:cNvPr>
          <p:cNvSpPr txBox="1"/>
          <p:nvPr/>
        </p:nvSpPr>
        <p:spPr>
          <a:xfrm>
            <a:off x="7941886" y="1354397"/>
            <a:ext cx="6351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.006</a:t>
            </a:r>
          </a:p>
        </p:txBody>
      </p:sp>
      <p:sp>
        <p:nvSpPr>
          <p:cNvPr id="14" name="AutoShape 4">
            <a:extLst>
              <a:ext uri="{FF2B5EF4-FFF2-40B4-BE49-F238E27FC236}">
                <a16:creationId xmlns:a16="http://schemas.microsoft.com/office/drawing/2014/main" id="{38CEF751-7D7E-51C4-253C-D33EC029989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6CF43DD-827F-5F38-48A8-9A2F136F5E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6908" y="1616007"/>
            <a:ext cx="3090505" cy="238024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0AAA8AC-8BC4-C3EB-EAFA-028601C66FB2}"/>
              </a:ext>
            </a:extLst>
          </p:cNvPr>
          <p:cNvSpPr txBox="1"/>
          <p:nvPr/>
        </p:nvSpPr>
        <p:spPr>
          <a:xfrm>
            <a:off x="1825462" y="1693149"/>
            <a:ext cx="6351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=0.037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0CD5BDBC-6ECB-24D2-F582-B3D6F6118D2E}"/>
              </a:ext>
            </a:extLst>
          </p:cNvPr>
          <p:cNvCxnSpPr/>
          <p:nvPr/>
        </p:nvCxnSpPr>
        <p:spPr>
          <a:xfrm>
            <a:off x="1549400" y="1905300"/>
            <a:ext cx="118723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8D1B04A-F8F8-54EA-009E-98327C8C6A73}"/>
              </a:ext>
            </a:extLst>
          </p:cNvPr>
          <p:cNvCxnSpPr/>
          <p:nvPr/>
        </p:nvCxnSpPr>
        <p:spPr>
          <a:xfrm>
            <a:off x="7683500" y="1616007"/>
            <a:ext cx="118723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416773BB-F26C-AE15-1545-ED7C9CB6FC5D}"/>
              </a:ext>
            </a:extLst>
          </p:cNvPr>
          <p:cNvSpPr txBox="1"/>
          <p:nvPr/>
        </p:nvSpPr>
        <p:spPr>
          <a:xfrm>
            <a:off x="-12639" y="4208402"/>
            <a:ext cx="12217277" cy="438582"/>
          </a:xfrm>
          <a:prstGeom prst="rect">
            <a:avLst/>
          </a:prstGeom>
          <a:noFill/>
        </p:spPr>
        <p:txBody>
          <a:bodyPr wrap="square" lIns="68580" tIns="34290" rIns="68580" bIns="34290" anchor="t">
            <a:spAutoFit/>
          </a:bodyPr>
          <a:lstStyle/>
          <a:p>
            <a:pPr defTabSz="342900"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1:  Derived shear stress-gradient RBCD measures in participants included from osmotic-gradient studies. (A)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Imax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 the diabetes cohort (n=49) and nondiabetic controls (n=40) for participants included in osmotic gradient studies. </a:t>
            </a:r>
            <a:r>
              <a:rPr lang="en-US" sz="1200" dirty="0">
                <a:latin typeface="Calibri" panose="020F0502020204030204"/>
              </a:rPr>
              <a:t>(B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S</a:t>
            </a:r>
            <a:r>
              <a:rPr kumimoji="0" lang="en-US" sz="1200" b="0" i="0" u="none" strike="noStrike" kern="1200" cap="none" spc="0" normalizeH="0" baseline="-2500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/2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n the diabetes cohort (n=49) and nondiabetic controls (n=40) for participants included in osmotic gradient studies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829218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F7EC423-9F99-5A22-53AD-BA0DD9E4BF53}"/>
              </a:ext>
            </a:extLst>
          </p:cNvPr>
          <p:cNvSpPr txBox="1"/>
          <p:nvPr/>
        </p:nvSpPr>
        <p:spPr>
          <a:xfrm>
            <a:off x="487988" y="853192"/>
            <a:ext cx="312929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earson's Correlation between Osmotic Fragility (</a:t>
            </a:r>
            <a:r>
              <a:rPr kumimoji="0" lang="en-US" sz="11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min</a:t>
            </a:r>
            <a:r>
              <a:rPr kumimoji="0" lang="en-US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 and Hgb-O2 dissociation (p50) in the diabetic cohor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C537035-4AB3-B925-7041-466835F16231}"/>
              </a:ext>
            </a:extLst>
          </p:cNvPr>
          <p:cNvSpPr txBox="1"/>
          <p:nvPr/>
        </p:nvSpPr>
        <p:spPr>
          <a:xfrm>
            <a:off x="358768" y="752938"/>
            <a:ext cx="258440" cy="253916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>
                <a:solidFill>
                  <a:prstClr val="black"/>
                </a:solidFill>
                <a:latin typeface="Calibri" panose="020F0502020204030204"/>
              </a:rPr>
              <a:t>A</a:t>
            </a:r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81221C-98B5-F0A5-7534-95C6DF1EDAD8}"/>
              </a:ext>
            </a:extLst>
          </p:cNvPr>
          <p:cNvSpPr txBox="1"/>
          <p:nvPr/>
        </p:nvSpPr>
        <p:spPr>
          <a:xfrm>
            <a:off x="0" y="-17043"/>
            <a:ext cx="2356944" cy="284693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2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EA7154D7-DA00-9F5D-7418-A1A6B52395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4240318"/>
              </p:ext>
            </p:extLst>
          </p:nvPr>
        </p:nvGraphicFramePr>
        <p:xfrm>
          <a:off x="319088" y="1341438"/>
          <a:ext cx="3670300" cy="2087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212604" imgH="2966949" progId="Prism10.Document">
                  <p:embed/>
                </p:oleObj>
              </mc:Choice>
              <mc:Fallback>
                <p:oleObj name="Prism 10" r:id="rId2" imgW="5212604" imgH="2966949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EA7154D7-DA00-9F5D-7418-A1A6B52395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9088" y="1341438"/>
                        <a:ext cx="3670300" cy="2087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B480124-CF84-82B4-C20B-2488767000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8694186"/>
              </p:ext>
            </p:extLst>
          </p:nvPr>
        </p:nvGraphicFramePr>
        <p:xfrm>
          <a:off x="4268452" y="1161430"/>
          <a:ext cx="5050173" cy="122046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98998">
                  <a:extLst>
                    <a:ext uri="{9D8B030D-6E8A-4147-A177-3AD203B41FA5}">
                      <a16:colId xmlns:a16="http://schemas.microsoft.com/office/drawing/2014/main" val="1846405378"/>
                    </a:ext>
                  </a:extLst>
                </a:gridCol>
                <a:gridCol w="1132380">
                  <a:extLst>
                    <a:ext uri="{9D8B030D-6E8A-4147-A177-3AD203B41FA5}">
                      <a16:colId xmlns:a16="http://schemas.microsoft.com/office/drawing/2014/main" val="1113453432"/>
                    </a:ext>
                  </a:extLst>
                </a:gridCol>
                <a:gridCol w="808842">
                  <a:extLst>
                    <a:ext uri="{9D8B030D-6E8A-4147-A177-3AD203B41FA5}">
                      <a16:colId xmlns:a16="http://schemas.microsoft.com/office/drawing/2014/main" val="1308824619"/>
                    </a:ext>
                  </a:extLst>
                </a:gridCol>
                <a:gridCol w="808842">
                  <a:extLst>
                    <a:ext uri="{9D8B030D-6E8A-4147-A177-3AD203B41FA5}">
                      <a16:colId xmlns:a16="http://schemas.microsoft.com/office/drawing/2014/main" val="3184722069"/>
                    </a:ext>
                  </a:extLst>
                </a:gridCol>
                <a:gridCol w="901111">
                  <a:extLst>
                    <a:ext uri="{9D8B030D-6E8A-4147-A177-3AD203B41FA5}">
                      <a16:colId xmlns:a16="http://schemas.microsoft.com/office/drawing/2014/main" val="3736162385"/>
                    </a:ext>
                  </a:extLst>
                </a:gridCol>
              </a:tblGrid>
              <a:tr h="34290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Glycemic Parameters</a:t>
                      </a:r>
                      <a:endParaRPr lang="en-US" sz="1000" kern="100">
                        <a:effectLst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(Mean/SD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Low tertile</a:t>
                      </a:r>
                      <a:endParaRPr lang="en-US" sz="1000" kern="100">
                        <a:effectLst/>
                      </a:endParaRPr>
                    </a:p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N=24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Medium tertile</a:t>
                      </a:r>
                      <a:endParaRPr lang="en-US" sz="1000" kern="100">
                        <a:effectLst/>
                      </a:endParaRPr>
                    </a:p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N=28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High tertile</a:t>
                      </a:r>
                      <a:endParaRPr lang="en-US" sz="1000" kern="100">
                        <a:effectLst/>
                      </a:endParaRPr>
                    </a:p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N=26 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 </a:t>
                      </a:r>
                      <a:endParaRPr lang="en-US" sz="1000" kern="100">
                        <a:effectLst/>
                      </a:endParaRPr>
                    </a:p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 </a:t>
                      </a:r>
                      <a:endParaRPr lang="en-US" sz="1000" kern="100">
                        <a:effectLst/>
                      </a:endParaRPr>
                    </a:p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Low vs High </a:t>
                      </a:r>
                      <a:endParaRPr lang="en-US" sz="1000" kern="100">
                        <a:effectLst/>
                      </a:endParaRPr>
                    </a:p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Tertile (p-value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4271481354"/>
                  </a:ext>
                </a:extLst>
              </a:tr>
              <a:tr h="283177">
                <a:tc>
                  <a:txBody>
                    <a:bodyPr/>
                    <a:lstStyle/>
                    <a:p>
                      <a:pPr marL="0" marR="0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Fasting Glucose (mg/dL)</a:t>
                      </a:r>
                      <a:endParaRPr lang="en-US" sz="1000" kern="100">
                        <a:effectLst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164.3 (58.7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137.1 (35.3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140 (58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0.1007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19825783"/>
                  </a:ext>
                </a:extLst>
              </a:tr>
              <a:tr h="299431">
                <a:tc>
                  <a:txBody>
                    <a:bodyPr/>
                    <a:lstStyle/>
                    <a:p>
                      <a:pPr marL="0" marR="0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Hemoglobin A1C (%)</a:t>
                      </a:r>
                      <a:r>
                        <a:rPr lang="en-US" sz="1000" kern="1200" baseline="30000">
                          <a:effectLst/>
                        </a:rPr>
                        <a:t> 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7.8 (1.2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7.9 (1.5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7.9 (1.3)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0.9331</a:t>
                      </a:r>
                      <a:endParaRPr lang="en-US" sz="10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824456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8AC2C90-3A78-884E-773B-686840E54B75}"/>
              </a:ext>
            </a:extLst>
          </p:cNvPr>
          <p:cNvSpPr txBox="1"/>
          <p:nvPr/>
        </p:nvSpPr>
        <p:spPr>
          <a:xfrm>
            <a:off x="4268452" y="644534"/>
            <a:ext cx="258440" cy="238527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>
                <a:solidFill>
                  <a:prstClr val="black"/>
                </a:solidFill>
                <a:latin typeface="Calibri" panose="020F0502020204030204"/>
              </a:rPr>
              <a:t>B</a:t>
            </a:r>
            <a:endParaRPr kumimoji="0" lang="en-US" sz="11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A997E20-FD00-7074-A797-5F24546792F1}"/>
              </a:ext>
            </a:extLst>
          </p:cNvPr>
          <p:cNvSpPr txBox="1"/>
          <p:nvPr/>
        </p:nvSpPr>
        <p:spPr>
          <a:xfrm>
            <a:off x="4526891" y="625519"/>
            <a:ext cx="4791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>
                <a:solidFill>
                  <a:prstClr val="black"/>
                </a:solidFill>
                <a:latin typeface="Calibri" panose="020F0502020204030204"/>
              </a:rPr>
              <a:t>Glycemic parameters within the diabetes cohort, categorized by stratified by low, medium and high SS1/2 tertiles</a:t>
            </a:r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95BC6B33-3C79-6C59-9FC8-B55DAC757E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526816"/>
              </p:ext>
            </p:extLst>
          </p:nvPr>
        </p:nvGraphicFramePr>
        <p:xfrm>
          <a:off x="500063" y="4222750"/>
          <a:ext cx="2806700" cy="2009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159207" imgH="2975953" progId="Prism10.Document">
                  <p:embed/>
                </p:oleObj>
              </mc:Choice>
              <mc:Fallback>
                <p:oleObj name="Prism 10" r:id="rId4" imgW="4159207" imgH="2975953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95BC6B33-3C79-6C59-9FC8-B55DAC757E5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0063" y="4222750"/>
                        <a:ext cx="2806700" cy="20097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E8AB19D-13D4-4C34-D5B0-91AFDA3CC5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5954857"/>
              </p:ext>
            </p:extLst>
          </p:nvPr>
        </p:nvGraphicFramePr>
        <p:xfrm>
          <a:off x="4233863" y="4156075"/>
          <a:ext cx="2998787" cy="2076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713816" imgH="2975953" progId="Prism10.Document">
                  <p:embed/>
                </p:oleObj>
              </mc:Choice>
              <mc:Fallback>
                <p:oleObj name="Prism 10" r:id="rId6" imgW="4713816" imgH="297595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7E8AB19D-13D4-4C34-D5B0-91AFDA3CC5A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33863" y="4156075"/>
                        <a:ext cx="2998787" cy="207645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AAEE29E1-987B-E445-B238-40953217D1EB}"/>
              </a:ext>
            </a:extLst>
          </p:cNvPr>
          <p:cNvSpPr txBox="1"/>
          <p:nvPr/>
        </p:nvSpPr>
        <p:spPr>
          <a:xfrm>
            <a:off x="671481" y="4222706"/>
            <a:ext cx="258440" cy="238527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94B2DA-312C-D3FF-2929-0D37CB5814BC}"/>
              </a:ext>
            </a:extLst>
          </p:cNvPr>
          <p:cNvSpPr txBox="1"/>
          <p:nvPr/>
        </p:nvSpPr>
        <p:spPr>
          <a:xfrm>
            <a:off x="4204952" y="4099648"/>
            <a:ext cx="258440" cy="238527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BD29023-4CDE-FF47-78F6-CEAEC6C826D2}"/>
              </a:ext>
            </a:extLst>
          </p:cNvPr>
          <p:cNvSpPr txBox="1"/>
          <p:nvPr/>
        </p:nvSpPr>
        <p:spPr>
          <a:xfrm>
            <a:off x="487988" y="3725910"/>
            <a:ext cx="312929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earson's Correlation between plasma glucose and Hgb-O2 dissociation (p50) in the diabetic cohor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B9998F6-F1FA-3C2A-89DC-45B7D2C0EAE8}"/>
              </a:ext>
            </a:extLst>
          </p:cNvPr>
          <p:cNvSpPr txBox="1"/>
          <p:nvPr/>
        </p:nvSpPr>
        <p:spPr>
          <a:xfrm>
            <a:off x="4397672" y="3668761"/>
            <a:ext cx="312929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earson's Correlation between Hemoglobin A1C and Hgb-O2 dissociation (p50) in the diabetic cohor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ECF3F3-AA4B-0580-4E3D-2F68D70ED476}"/>
              </a:ext>
            </a:extLst>
          </p:cNvPr>
          <p:cNvSpPr txBox="1"/>
          <p:nvPr/>
        </p:nvSpPr>
        <p:spPr>
          <a:xfrm>
            <a:off x="7833821" y="4461233"/>
            <a:ext cx="435817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 (A) Associations between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gb-O2 dissociation (p50) and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min</a:t>
            </a:r>
            <a:r>
              <a:rPr lang="en-US" sz="1200" dirty="0">
                <a:latin typeface="Segoe UI" panose="020B0502040204020203" pitchFamily="34" charset="0"/>
              </a:rPr>
              <a:t>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within diabetes cohort. </a:t>
            </a:r>
            <a:r>
              <a:rPr lang="en-US" sz="1200" dirty="0">
                <a:latin typeface="Segoe UI" panose="020B0502040204020203" pitchFamily="34" charset="0"/>
              </a:rPr>
              <a:t>(B) Glycemic parameters within the diabetes cohort stratified by SS</a:t>
            </a:r>
            <a:r>
              <a:rPr lang="en-US" sz="1200" baseline="-25000" dirty="0">
                <a:latin typeface="Segoe UI" panose="020B0502040204020203" pitchFamily="34" charset="0"/>
              </a:rPr>
              <a:t>1/2</a:t>
            </a:r>
            <a:r>
              <a:rPr lang="en-US" sz="1200" dirty="0">
                <a:latin typeface="Segoe UI" panose="020B0502040204020203" pitchFamily="34" charset="0"/>
              </a:rPr>
              <a:t> tertiles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(C) Association between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gb-O2 dissociation (p50) and plasma glucose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within diabetes cohort. (D) Association between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gb-O2 dissociation (p50) and hemoglobin A1C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within diabetes cohort. For panels A, C and D, Pearson correlation (on Box-Cox transformed data) and associated confidence interval are shown in each figure for each cohort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808459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8AAA4EE-5844-CA73-344A-BCC758EA29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4075994"/>
              </p:ext>
            </p:extLst>
          </p:nvPr>
        </p:nvGraphicFramePr>
        <p:xfrm>
          <a:off x="4321783" y="1852137"/>
          <a:ext cx="3527034" cy="20484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145619" imgH="2709439" progId="Prism10.Document">
                  <p:embed/>
                </p:oleObj>
              </mc:Choice>
              <mc:Fallback>
                <p:oleObj name="Prism 10" r:id="rId2" imgW="5145619" imgH="270943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8AAA4EE-5844-CA73-344A-BCC758EA29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21783" y="1852137"/>
                        <a:ext cx="3527034" cy="20484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FEBBFB41-C6E7-A938-AEFB-CECEFFF0EBEE}"/>
              </a:ext>
            </a:extLst>
          </p:cNvPr>
          <p:cNvSpPr txBox="1"/>
          <p:nvPr/>
        </p:nvSpPr>
        <p:spPr>
          <a:xfrm>
            <a:off x="86169" y="258309"/>
            <a:ext cx="12019661" cy="407804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3:  Sex differences, diabetes status and RBC measures</a:t>
            </a:r>
          </a:p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B6C636-A3C4-5173-FD84-D76AE2B0734A}"/>
              </a:ext>
            </a:extLst>
          </p:cNvPr>
          <p:cNvSpPr txBox="1"/>
          <p:nvPr/>
        </p:nvSpPr>
        <p:spPr>
          <a:xfrm>
            <a:off x="817372" y="1513520"/>
            <a:ext cx="258440" cy="253916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C3899AE-C396-1692-F693-640B58BAEB04}"/>
              </a:ext>
            </a:extLst>
          </p:cNvPr>
          <p:cNvSpPr txBox="1"/>
          <p:nvPr/>
        </p:nvSpPr>
        <p:spPr>
          <a:xfrm>
            <a:off x="2678445" y="5260525"/>
            <a:ext cx="627172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(A) Hemoglobin concentrations in between male and female participants with and without diabetes. (</a:t>
            </a:r>
            <a:r>
              <a:rPr lang="en-US" sz="1200" dirty="0">
                <a:latin typeface="Segoe UI" panose="020B0502040204020203" pitchFamily="34" charset="0"/>
              </a:rPr>
              <a:t>B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) Associations between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Ohyper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 and MCHC within diabetes cohort (red circles) and within the nondiabetic controls (blue circles). Pearson correlation (on 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Box-Cox transformed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 panose="020B0502040204020203" pitchFamily="34" charset="0"/>
                <a:ea typeface="+mn-ea"/>
                <a:cs typeface="+mn-cs"/>
              </a:rPr>
              <a:t>data) and associated confidence interval are shown in each figure for each cohort. (C) MCHC comparisons in male and female participants with and without diabetes. NS, Non-significant at 0.05 level.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0E0FD1-32A5-0C57-81A8-FAA5BC94B32F}"/>
              </a:ext>
            </a:extLst>
          </p:cNvPr>
          <p:cNvSpPr txBox="1"/>
          <p:nvPr/>
        </p:nvSpPr>
        <p:spPr>
          <a:xfrm>
            <a:off x="4512150" y="1564677"/>
            <a:ext cx="258440" cy="253916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pic>
        <p:nvPicPr>
          <p:cNvPr id="1028" name="Picture 1027">
            <a:extLst>
              <a:ext uri="{FF2B5EF4-FFF2-40B4-BE49-F238E27FC236}">
                <a16:creationId xmlns:a16="http://schemas.microsoft.com/office/drawing/2014/main" id="{6831387B-234F-E83D-2A47-B57AE0A4E8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86311" y="1752206"/>
            <a:ext cx="2663052" cy="2302330"/>
          </a:xfrm>
          <a:prstGeom prst="rect">
            <a:avLst/>
          </a:prstGeom>
        </p:spPr>
      </p:pic>
      <p:pic>
        <p:nvPicPr>
          <p:cNvPr id="1034" name="Picture 1033">
            <a:extLst>
              <a:ext uri="{FF2B5EF4-FFF2-40B4-BE49-F238E27FC236}">
                <a16:creationId xmlns:a16="http://schemas.microsoft.com/office/drawing/2014/main" id="{0542FE44-6B46-641F-9BA5-15B37D458D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6592" y="1902653"/>
            <a:ext cx="2618754" cy="2395728"/>
          </a:xfrm>
          <a:prstGeom prst="rect">
            <a:avLst/>
          </a:prstGeom>
        </p:spPr>
      </p:pic>
      <p:cxnSp>
        <p:nvCxnSpPr>
          <p:cNvPr id="1029" name="Straight Connector 1028">
            <a:extLst>
              <a:ext uri="{FF2B5EF4-FFF2-40B4-BE49-F238E27FC236}">
                <a16:creationId xmlns:a16="http://schemas.microsoft.com/office/drawing/2014/main" id="{1C70D4F4-4BA7-6E1A-E45B-A9A24F257D40}"/>
              </a:ext>
            </a:extLst>
          </p:cNvPr>
          <p:cNvCxnSpPr>
            <a:cxnSpLocks/>
          </p:cNvCxnSpPr>
          <p:nvPr/>
        </p:nvCxnSpPr>
        <p:spPr>
          <a:xfrm>
            <a:off x="1504597" y="1831623"/>
            <a:ext cx="471503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0" name="Straight Connector 1029">
            <a:extLst>
              <a:ext uri="{FF2B5EF4-FFF2-40B4-BE49-F238E27FC236}">
                <a16:creationId xmlns:a16="http://schemas.microsoft.com/office/drawing/2014/main" id="{E5F6D749-7EDC-C5DF-6956-A1738A20F5BA}"/>
              </a:ext>
            </a:extLst>
          </p:cNvPr>
          <p:cNvCxnSpPr>
            <a:cxnSpLocks/>
          </p:cNvCxnSpPr>
          <p:nvPr/>
        </p:nvCxnSpPr>
        <p:spPr>
          <a:xfrm>
            <a:off x="2255969" y="1830889"/>
            <a:ext cx="475488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1" name="TextBox 1030">
            <a:extLst>
              <a:ext uri="{FF2B5EF4-FFF2-40B4-BE49-F238E27FC236}">
                <a16:creationId xmlns:a16="http://schemas.microsoft.com/office/drawing/2014/main" id="{118F37BE-7487-0AC7-14BD-8AC0E8E2D57A}"/>
              </a:ext>
            </a:extLst>
          </p:cNvPr>
          <p:cNvSpPr txBox="1"/>
          <p:nvPr/>
        </p:nvSpPr>
        <p:spPr>
          <a:xfrm>
            <a:off x="1446871" y="1604453"/>
            <a:ext cx="6094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&lt;0.001</a:t>
            </a:r>
          </a:p>
        </p:txBody>
      </p:sp>
      <p:sp>
        <p:nvSpPr>
          <p:cNvPr id="1032" name="TextBox 1031">
            <a:extLst>
              <a:ext uri="{FF2B5EF4-FFF2-40B4-BE49-F238E27FC236}">
                <a16:creationId xmlns:a16="http://schemas.microsoft.com/office/drawing/2014/main" id="{BFD8A151-F263-2451-7BE5-5EF0BD5007B3}"/>
              </a:ext>
            </a:extLst>
          </p:cNvPr>
          <p:cNvSpPr txBox="1"/>
          <p:nvPr/>
        </p:nvSpPr>
        <p:spPr>
          <a:xfrm>
            <a:off x="2229428" y="1644444"/>
            <a:ext cx="6094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&lt;0.00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0414CE3-901F-676B-AD6F-28270791524F}"/>
              </a:ext>
            </a:extLst>
          </p:cNvPr>
          <p:cNvSpPr txBox="1"/>
          <p:nvPr/>
        </p:nvSpPr>
        <p:spPr>
          <a:xfrm>
            <a:off x="8571016" y="1564677"/>
            <a:ext cx="230590" cy="253916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C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D6D042F-2CF0-6900-E669-50335A2EC9EF}"/>
              </a:ext>
            </a:extLst>
          </p:cNvPr>
          <p:cNvSpPr txBox="1"/>
          <p:nvPr/>
        </p:nvSpPr>
        <p:spPr>
          <a:xfrm>
            <a:off x="9953838" y="1640478"/>
            <a:ext cx="6161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/>
              <a:t>P&lt;0.001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502AAC68-BF66-DB47-C8E6-2BC24F9241CF}"/>
              </a:ext>
            </a:extLst>
          </p:cNvPr>
          <p:cNvCxnSpPr>
            <a:cxnSpLocks/>
          </p:cNvCxnSpPr>
          <p:nvPr/>
        </p:nvCxnSpPr>
        <p:spPr>
          <a:xfrm>
            <a:off x="10058911" y="1830889"/>
            <a:ext cx="340416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5" name="TextBox 1034">
            <a:extLst>
              <a:ext uri="{FF2B5EF4-FFF2-40B4-BE49-F238E27FC236}">
                <a16:creationId xmlns:a16="http://schemas.microsoft.com/office/drawing/2014/main" id="{571CA029-212B-AE66-C00E-5AB59BAA2449}"/>
              </a:ext>
            </a:extLst>
          </p:cNvPr>
          <p:cNvSpPr txBox="1"/>
          <p:nvPr/>
        </p:nvSpPr>
        <p:spPr>
          <a:xfrm>
            <a:off x="9331711" y="1640478"/>
            <a:ext cx="343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NS</a:t>
            </a:r>
          </a:p>
        </p:txBody>
      </p:sp>
      <p:cxnSp>
        <p:nvCxnSpPr>
          <p:cNvPr id="1062" name="Straight Connector 1061">
            <a:extLst>
              <a:ext uri="{FF2B5EF4-FFF2-40B4-BE49-F238E27FC236}">
                <a16:creationId xmlns:a16="http://schemas.microsoft.com/office/drawing/2014/main" id="{B92ED3D0-642C-A60A-C16F-C7388554C5FC}"/>
              </a:ext>
            </a:extLst>
          </p:cNvPr>
          <p:cNvCxnSpPr>
            <a:cxnSpLocks/>
          </p:cNvCxnSpPr>
          <p:nvPr/>
        </p:nvCxnSpPr>
        <p:spPr>
          <a:xfrm>
            <a:off x="9335011" y="1830889"/>
            <a:ext cx="340416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769122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C3B56DD9-8604-8F09-4025-90207F6943F8}"/>
              </a:ext>
            </a:extLst>
          </p:cNvPr>
          <p:cNvSpPr txBox="1"/>
          <p:nvPr/>
        </p:nvSpPr>
        <p:spPr>
          <a:xfrm>
            <a:off x="429800" y="980066"/>
            <a:ext cx="35510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A</a:t>
            </a:r>
            <a:endParaRPr lang="en-US" sz="11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5EBB9DE-E77D-9898-AFE2-A238DE725E70}"/>
              </a:ext>
            </a:extLst>
          </p:cNvPr>
          <p:cNvSpPr txBox="1"/>
          <p:nvPr/>
        </p:nvSpPr>
        <p:spPr>
          <a:xfrm>
            <a:off x="4465574" y="987504"/>
            <a:ext cx="4247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B</a:t>
            </a:r>
            <a:endParaRPr lang="en-US" sz="11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0FEEC0C-261F-1B09-103F-EFE5155D512E}"/>
              </a:ext>
            </a:extLst>
          </p:cNvPr>
          <p:cNvSpPr txBox="1"/>
          <p:nvPr/>
        </p:nvSpPr>
        <p:spPr>
          <a:xfrm>
            <a:off x="8383379" y="987504"/>
            <a:ext cx="41363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C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2A3B5F-487F-33C1-CDF7-E75FFA6F70FA}"/>
              </a:ext>
            </a:extLst>
          </p:cNvPr>
          <p:cNvSpPr txBox="1"/>
          <p:nvPr/>
        </p:nvSpPr>
        <p:spPr>
          <a:xfrm>
            <a:off x="-1" y="26856"/>
            <a:ext cx="9703294" cy="284693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4: Analysis of selection bias in participants with vs without RBC physiologic parameters </a:t>
            </a:r>
          </a:p>
        </p:txBody>
      </p:sp>
      <p:sp>
        <p:nvSpPr>
          <p:cNvPr id="18" name="AutoShape 4">
            <a:extLst>
              <a:ext uri="{FF2B5EF4-FFF2-40B4-BE49-F238E27FC236}">
                <a16:creationId xmlns:a16="http://schemas.microsoft.com/office/drawing/2014/main" id="{35094058-6BB2-23E3-8734-18E309EAFEA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6096000" y="34290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0641B85-841C-24A6-7ADD-EDDA569324C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2800" r="1238"/>
          <a:stretch/>
        </p:blipFill>
        <p:spPr>
          <a:xfrm>
            <a:off x="7791390" y="1264503"/>
            <a:ext cx="3632222" cy="261524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701C5F41-12B1-EA4C-BE24-77DA800E0A0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3039" r="2170"/>
          <a:stretch/>
        </p:blipFill>
        <p:spPr>
          <a:xfrm>
            <a:off x="3859762" y="1241676"/>
            <a:ext cx="3623251" cy="266090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BC9641A4-2D44-B559-EF40-33DF352A7E3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3507" r="3221"/>
          <a:stretch/>
        </p:blipFill>
        <p:spPr>
          <a:xfrm>
            <a:off x="279762" y="1241676"/>
            <a:ext cx="3285446" cy="2537476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9CEB9ADE-E2F4-7C7F-168F-0275A943A0AF}"/>
              </a:ext>
            </a:extLst>
          </p:cNvPr>
          <p:cNvSpPr txBox="1"/>
          <p:nvPr/>
        </p:nvSpPr>
        <p:spPr>
          <a:xfrm>
            <a:off x="2263190" y="4831494"/>
            <a:ext cx="7271427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Plots of standardized mean differences in demographic parameters of participants with vs without NaCl 50% hemolysis values (A), osmotic gradient ektacytometry studies (B) and hemoglobin-oxygen dissociation studies (C ). N, non-diabetic cohort, D, diabetes cohort; </a:t>
            </a:r>
            <a:r>
              <a:rPr lang="en-US" sz="1200" dirty="0">
                <a:solidFill>
                  <a:srgbClr val="C388F2"/>
                </a:solidFill>
              </a:rPr>
              <a:t>●</a:t>
            </a:r>
            <a:r>
              <a:rPr lang="en-US" sz="1200" dirty="0"/>
              <a:t>  pooled values of the combined cohorts.</a:t>
            </a:r>
          </a:p>
          <a:p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1199592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FA4212-2516-429F-82BB-FDD041957845}"/>
              </a:ext>
            </a:extLst>
          </p:cNvPr>
          <p:cNvSpPr txBox="1"/>
          <p:nvPr/>
        </p:nvSpPr>
        <p:spPr>
          <a:xfrm>
            <a:off x="-30457" y="0"/>
            <a:ext cx="18556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Table 1</a:t>
            </a:r>
          </a:p>
        </p:txBody>
      </p:sp>
      <p:sp>
        <p:nvSpPr>
          <p:cNvPr id="9" name="Freeform 238">
            <a:extLst>
              <a:ext uri="{FF2B5EF4-FFF2-40B4-BE49-F238E27FC236}">
                <a16:creationId xmlns:a16="http://schemas.microsoft.com/office/drawing/2014/main" id="{239C9740-2BB3-B766-1E1C-395627E8558A}"/>
              </a:ext>
            </a:extLst>
          </p:cNvPr>
          <p:cNvSpPr>
            <a:spLocks/>
          </p:cNvSpPr>
          <p:nvPr/>
        </p:nvSpPr>
        <p:spPr bwMode="auto">
          <a:xfrm>
            <a:off x="5554663" y="7112001"/>
            <a:ext cx="30163" cy="0"/>
          </a:xfrm>
          <a:custGeom>
            <a:avLst/>
            <a:gdLst>
              <a:gd name="T0" fmla="*/ 0 w 5"/>
              <a:gd name="T1" fmla="*/ 4 w 5"/>
            </a:gdLst>
            <a:ahLst/>
            <a:cxnLst>
              <a:cxn ang="0">
                <a:pos x="T0" y="0"/>
              </a:cxn>
              <a:cxn ang="0">
                <a:pos x="T1" y="0"/>
              </a:cxn>
            </a:cxnLst>
            <a:rect l="0" t="0" r="r" b="b"/>
            <a:pathLst>
              <a:path w="5">
                <a:moveTo>
                  <a:pt x="4" y="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Freeform 252">
            <a:extLst>
              <a:ext uri="{FF2B5EF4-FFF2-40B4-BE49-F238E27FC236}">
                <a16:creationId xmlns:a16="http://schemas.microsoft.com/office/drawing/2014/main" id="{9F450CD7-3F70-BE86-B182-51824406A598}"/>
              </a:ext>
            </a:extLst>
          </p:cNvPr>
          <p:cNvSpPr>
            <a:spLocks/>
          </p:cNvSpPr>
          <p:nvPr/>
        </p:nvSpPr>
        <p:spPr bwMode="auto">
          <a:xfrm>
            <a:off x="6245226" y="7834313"/>
            <a:ext cx="36513" cy="0"/>
          </a:xfrm>
          <a:custGeom>
            <a:avLst/>
            <a:gdLst>
              <a:gd name="T0" fmla="*/ 0 w 6"/>
              <a:gd name="T1" fmla="*/ 4 w 6"/>
            </a:gdLst>
            <a:ahLst/>
            <a:cxnLst>
              <a:cxn ang="0">
                <a:pos x="T0" y="0"/>
              </a:cxn>
              <a:cxn ang="0">
                <a:pos x="T1" y="0"/>
              </a:cxn>
            </a:cxnLst>
            <a:rect l="0" t="0" r="r" b="b"/>
            <a:pathLst>
              <a:path w="6">
                <a:moveTo>
                  <a:pt x="4" y="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CE76FA5-79FD-DE2F-5F22-2B00F9016EE3}"/>
              </a:ext>
            </a:extLst>
          </p:cNvPr>
          <p:cNvSpPr txBox="1"/>
          <p:nvPr/>
        </p:nvSpPr>
        <p:spPr>
          <a:xfrm>
            <a:off x="167514" y="371792"/>
            <a:ext cx="4403558" cy="5078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defRPr/>
            </a:pP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: Data for </a:t>
            </a:r>
            <a:r>
              <a:rPr lang="en-US" sz="1350" dirty="0">
                <a:solidFill>
                  <a:prstClr val="black"/>
                </a:solidFill>
                <a:latin typeface="Calibri" panose="020F0502020204030204"/>
              </a:rPr>
              <a:t>model-estimated differences</a:t>
            </a: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of the </a:t>
            </a:r>
            <a:r>
              <a:rPr lang="en-US" sz="1350" dirty="0">
                <a:solidFill>
                  <a:prstClr val="black"/>
                </a:solidFill>
                <a:latin typeface="Calibri" panose="020F0502020204030204"/>
              </a:rPr>
              <a:t>cohort means from the  'pooled' mean</a:t>
            </a: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plot (Figure 2A insert)</a:t>
            </a: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15167F7E-E66F-A610-70F0-3F2D04A4262B}"/>
              </a:ext>
            </a:extLst>
          </p:cNvPr>
          <p:cNvGraphicFramePr>
            <a:graphicFrameLocks noGrp="1"/>
          </p:cNvGraphicFramePr>
          <p:nvPr/>
        </p:nvGraphicFramePr>
        <p:xfrm>
          <a:off x="373603" y="879664"/>
          <a:ext cx="4565152" cy="2207936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649453">
                  <a:extLst>
                    <a:ext uri="{9D8B030D-6E8A-4147-A177-3AD203B41FA5}">
                      <a16:colId xmlns:a16="http://schemas.microsoft.com/office/drawing/2014/main" val="2382406828"/>
                    </a:ext>
                  </a:extLst>
                </a:gridCol>
                <a:gridCol w="1393982">
                  <a:extLst>
                    <a:ext uri="{9D8B030D-6E8A-4147-A177-3AD203B41FA5}">
                      <a16:colId xmlns:a16="http://schemas.microsoft.com/office/drawing/2014/main" val="2644684052"/>
                    </a:ext>
                  </a:extLst>
                </a:gridCol>
                <a:gridCol w="1521717">
                  <a:extLst>
                    <a:ext uri="{9D8B030D-6E8A-4147-A177-3AD203B41FA5}">
                      <a16:colId xmlns:a16="http://schemas.microsoft.com/office/drawing/2014/main" val="2231434016"/>
                    </a:ext>
                  </a:extLst>
                </a:gridCol>
              </a:tblGrid>
              <a:tr h="223136">
                <a:tc>
                  <a:txBody>
                    <a:bodyPr/>
                    <a:lstStyle/>
                    <a:p>
                      <a:r>
                        <a:rPr lang="en-US" sz="1000"/>
                        <a:t>Shear Stress value (pascal)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/>
                        <a:t>Diabetes cohort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/>
                        <a:t>Nondiabetic controls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860025105"/>
                  </a:ext>
                </a:extLst>
              </a:tr>
              <a:tr h="207747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25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0264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827305713"/>
                  </a:ext>
                </a:extLst>
              </a:tr>
              <a:tr h="288642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5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67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0702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079966371"/>
                  </a:ext>
                </a:extLst>
              </a:tr>
              <a:tr h="207747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9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99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1036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2624199661"/>
                  </a:ext>
                </a:extLst>
              </a:tr>
              <a:tr h="207747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1.6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99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103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676263892"/>
                  </a:ext>
                </a:extLst>
              </a:tr>
              <a:tr h="24192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106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1107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2418887296"/>
                  </a:ext>
                </a:extLst>
              </a:tr>
              <a:tr h="207747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5.3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92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0956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4206621449"/>
                  </a:ext>
                </a:extLst>
              </a:tr>
              <a:tr h="207747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9.4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6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0716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1070042741"/>
                  </a:ext>
                </a:extLst>
              </a:tr>
              <a:tr h="207747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16.8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51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0533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891554414"/>
                  </a:ext>
                </a:extLst>
              </a:tr>
              <a:tr h="207747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3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-0.0046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u="none" strike="noStrike">
                          <a:effectLst/>
                        </a:rPr>
                        <a:t>0.00483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/>
                </a:tc>
                <a:extLst>
                  <a:ext uri="{0D108BD9-81ED-4DB2-BD59-A6C34878D82A}">
                    <a16:rowId xmlns:a16="http://schemas.microsoft.com/office/drawing/2014/main" val="317119794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E7B4427-3F7E-EE2F-65FA-6D855B4AB2EF}"/>
              </a:ext>
            </a:extLst>
          </p:cNvPr>
          <p:cNvSpPr txBox="1"/>
          <p:nvPr/>
        </p:nvSpPr>
        <p:spPr>
          <a:xfrm>
            <a:off x="167514" y="3363009"/>
            <a:ext cx="5222004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defRPr/>
            </a:pP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: Potentially confounding covariates included in adjusted analyses comparing RBCD curves in the diabetes cohort and nondiabetic controls</a:t>
            </a:r>
            <a:r>
              <a:rPr lang="en-US" sz="1350" dirty="0">
                <a:solidFill>
                  <a:prstClr val="black"/>
                </a:solidFill>
                <a:latin typeface="Calibri" panose="020F0502020204030204"/>
              </a:rPr>
              <a:t>; see the Supplementary Methods for rationale in selecting covariates.</a:t>
            </a:r>
            <a:endParaRPr kumimoji="0" lang="en-US" sz="13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D21CF29-6165-B626-B7E4-8FA28DD9C4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4206989"/>
              </p:ext>
            </p:extLst>
          </p:nvPr>
        </p:nvGraphicFramePr>
        <p:xfrm>
          <a:off x="373601" y="4286339"/>
          <a:ext cx="4565154" cy="2448603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718662">
                  <a:extLst>
                    <a:ext uri="{9D8B030D-6E8A-4147-A177-3AD203B41FA5}">
                      <a16:colId xmlns:a16="http://schemas.microsoft.com/office/drawing/2014/main" val="3105324777"/>
                    </a:ext>
                  </a:extLst>
                </a:gridCol>
                <a:gridCol w="2277294">
                  <a:extLst>
                    <a:ext uri="{9D8B030D-6E8A-4147-A177-3AD203B41FA5}">
                      <a16:colId xmlns:a16="http://schemas.microsoft.com/office/drawing/2014/main" val="3622762157"/>
                    </a:ext>
                  </a:extLst>
                </a:gridCol>
                <a:gridCol w="1569198">
                  <a:extLst>
                    <a:ext uri="{9D8B030D-6E8A-4147-A177-3AD203B41FA5}">
                      <a16:colId xmlns:a16="http://schemas.microsoft.com/office/drawing/2014/main" val="3686118966"/>
                    </a:ext>
                  </a:extLst>
                </a:gridCol>
              </a:tblGrid>
              <a:tr h="289289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0078948"/>
                  </a:ext>
                </a:extLst>
              </a:tr>
              <a:tr h="343080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>
                          <a:effectLst/>
                        </a:rPr>
                        <a:t>Covariates</a:t>
                      </a:r>
                      <a:endParaRPr lang="en-US" sz="9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 p-value for differences in cohort with diabetes vs nondiabetic controls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377255945"/>
                  </a:ext>
                </a:extLst>
              </a:tr>
              <a:tr h="179415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djusted fo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03937744"/>
                  </a:ext>
                </a:extLst>
              </a:tr>
              <a:tr h="16597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Ag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4723621"/>
                  </a:ext>
                </a:extLst>
              </a:tr>
              <a:tr h="16597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Plasma Glucos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19495185"/>
                  </a:ext>
                </a:extLst>
              </a:tr>
              <a:tr h="16252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HbA1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12696992"/>
                  </a:ext>
                </a:extLst>
              </a:tr>
              <a:tr h="16252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eGF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47951039"/>
                  </a:ext>
                </a:extLst>
              </a:tr>
              <a:tr h="16252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effectLst/>
                        </a:rPr>
                        <a:t>Sex (Female: Male)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39324866"/>
                  </a:ext>
                </a:extLst>
              </a:tr>
              <a:tr h="16252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effectLst/>
                        </a:rPr>
                        <a:t>Hemoglobin</a:t>
                      </a:r>
                      <a:endParaRPr lang="en-US" sz="900" b="0" u="none" strike="noStrike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847127313"/>
                  </a:ext>
                </a:extLst>
              </a:tr>
              <a:tr h="16252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Race/Ethnicit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60436152"/>
                  </a:ext>
                </a:extLst>
              </a:tr>
              <a:tr h="16252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All above covariate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&lt;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60123083"/>
                  </a:ext>
                </a:extLst>
              </a:tr>
              <a:tr h="16252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u="none" strike="noStrike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8440127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47918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FA4212-2516-429F-82BB-FDD041957845}"/>
              </a:ext>
            </a:extLst>
          </p:cNvPr>
          <p:cNvSpPr txBox="1"/>
          <p:nvPr/>
        </p:nvSpPr>
        <p:spPr>
          <a:xfrm>
            <a:off x="120463" y="0"/>
            <a:ext cx="18556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Table 2</a:t>
            </a:r>
          </a:p>
        </p:txBody>
      </p:sp>
      <p:sp>
        <p:nvSpPr>
          <p:cNvPr id="9" name="Freeform 238">
            <a:extLst>
              <a:ext uri="{FF2B5EF4-FFF2-40B4-BE49-F238E27FC236}">
                <a16:creationId xmlns:a16="http://schemas.microsoft.com/office/drawing/2014/main" id="{239C9740-2BB3-B766-1E1C-395627E8558A}"/>
              </a:ext>
            </a:extLst>
          </p:cNvPr>
          <p:cNvSpPr>
            <a:spLocks/>
          </p:cNvSpPr>
          <p:nvPr/>
        </p:nvSpPr>
        <p:spPr bwMode="auto">
          <a:xfrm>
            <a:off x="5554663" y="7112001"/>
            <a:ext cx="30163" cy="0"/>
          </a:xfrm>
          <a:custGeom>
            <a:avLst/>
            <a:gdLst>
              <a:gd name="T0" fmla="*/ 0 w 5"/>
              <a:gd name="T1" fmla="*/ 4 w 5"/>
            </a:gdLst>
            <a:ahLst/>
            <a:cxnLst>
              <a:cxn ang="0">
                <a:pos x="T0" y="0"/>
              </a:cxn>
              <a:cxn ang="0">
                <a:pos x="T1" y="0"/>
              </a:cxn>
            </a:cxnLst>
            <a:rect l="0" t="0" r="r" b="b"/>
            <a:pathLst>
              <a:path w="5">
                <a:moveTo>
                  <a:pt x="4" y="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Freeform 252">
            <a:extLst>
              <a:ext uri="{FF2B5EF4-FFF2-40B4-BE49-F238E27FC236}">
                <a16:creationId xmlns:a16="http://schemas.microsoft.com/office/drawing/2014/main" id="{9F450CD7-3F70-BE86-B182-51824406A598}"/>
              </a:ext>
            </a:extLst>
          </p:cNvPr>
          <p:cNvSpPr>
            <a:spLocks/>
          </p:cNvSpPr>
          <p:nvPr/>
        </p:nvSpPr>
        <p:spPr bwMode="auto">
          <a:xfrm>
            <a:off x="6245226" y="7834313"/>
            <a:ext cx="36513" cy="0"/>
          </a:xfrm>
          <a:custGeom>
            <a:avLst/>
            <a:gdLst>
              <a:gd name="T0" fmla="*/ 0 w 6"/>
              <a:gd name="T1" fmla="*/ 4 w 6"/>
            </a:gdLst>
            <a:ahLst/>
            <a:cxnLst>
              <a:cxn ang="0">
                <a:pos x="T0" y="0"/>
              </a:cxn>
              <a:cxn ang="0">
                <a:pos x="T1" y="0"/>
              </a:cxn>
            </a:cxnLst>
            <a:rect l="0" t="0" r="r" b="b"/>
            <a:pathLst>
              <a:path w="6">
                <a:moveTo>
                  <a:pt x="4" y="0"/>
                </a:move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DEAEC55-13E6-44C2-153B-1214CCE7FD13}"/>
              </a:ext>
            </a:extLst>
          </p:cNvPr>
          <p:cNvSpPr txBox="1"/>
          <p:nvPr/>
        </p:nvSpPr>
        <p:spPr>
          <a:xfrm>
            <a:off x="187763" y="2904909"/>
            <a:ext cx="5157788" cy="438582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: Summary of mean P-50 values in SS</a:t>
            </a:r>
            <a:r>
              <a:rPr kumimoji="0" lang="en-US" sz="1200" b="0" i="0" u="none" strike="noStrike" kern="1200" cap="none" spc="0" normalizeH="0" baseline="-2500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/2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ertiles in the diabetes cohort and nondiabetic controls (reference for Figure 6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47E863D-265C-C348-07B9-0C688D5D047D}"/>
              </a:ext>
            </a:extLst>
          </p:cNvPr>
          <p:cNvSpPr txBox="1"/>
          <p:nvPr/>
        </p:nvSpPr>
        <p:spPr>
          <a:xfrm>
            <a:off x="202002" y="456817"/>
            <a:ext cx="5143549" cy="438582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marL="0" marR="0" lvl="0" indent="0" algn="l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: Summary of mean </a:t>
            </a:r>
            <a:r>
              <a:rPr kumimoji="0" lang="en-US" sz="12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min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values in SS</a:t>
            </a:r>
            <a:r>
              <a:rPr kumimoji="0" lang="en-US" sz="1200" b="0" i="0" u="none" strike="noStrike" kern="1200" cap="none" spc="0" normalizeH="0" baseline="-2500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/2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ertiles in the diabetes cohort and nondiabetic controls (reference for Figure 5)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5AFE535-B3EF-B54F-D571-AA2583FA58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4381595"/>
              </p:ext>
            </p:extLst>
          </p:nvPr>
        </p:nvGraphicFramePr>
        <p:xfrm>
          <a:off x="246063" y="941793"/>
          <a:ext cx="5308600" cy="142843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63625">
                  <a:extLst>
                    <a:ext uri="{9D8B030D-6E8A-4147-A177-3AD203B41FA5}">
                      <a16:colId xmlns:a16="http://schemas.microsoft.com/office/drawing/2014/main" val="1775246214"/>
                    </a:ext>
                  </a:extLst>
                </a:gridCol>
                <a:gridCol w="1059815">
                  <a:extLst>
                    <a:ext uri="{9D8B030D-6E8A-4147-A177-3AD203B41FA5}">
                      <a16:colId xmlns:a16="http://schemas.microsoft.com/office/drawing/2014/main" val="768471482"/>
                    </a:ext>
                  </a:extLst>
                </a:gridCol>
                <a:gridCol w="1127760">
                  <a:extLst>
                    <a:ext uri="{9D8B030D-6E8A-4147-A177-3AD203B41FA5}">
                      <a16:colId xmlns:a16="http://schemas.microsoft.com/office/drawing/2014/main" val="2040840278"/>
                    </a:ext>
                  </a:extLst>
                </a:gridCol>
                <a:gridCol w="993140">
                  <a:extLst>
                    <a:ext uri="{9D8B030D-6E8A-4147-A177-3AD203B41FA5}">
                      <a16:colId xmlns:a16="http://schemas.microsoft.com/office/drawing/2014/main" val="1571535838"/>
                    </a:ext>
                  </a:extLst>
                </a:gridCol>
                <a:gridCol w="1064260">
                  <a:extLst>
                    <a:ext uri="{9D8B030D-6E8A-4147-A177-3AD203B41FA5}">
                      <a16:colId xmlns:a16="http://schemas.microsoft.com/office/drawing/2014/main" val="1633013767"/>
                    </a:ext>
                  </a:extLst>
                </a:gridCol>
              </a:tblGrid>
              <a:tr h="4413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Low Tertile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(mosm/k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Medium Terti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00" dirty="0">
                          <a:effectLst/>
                        </a:rPr>
                        <a:t>(mosm/k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High Terti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00" dirty="0">
                          <a:effectLst/>
                        </a:rPr>
                        <a:t>(mosm/k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Low vs High comparison 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6581932"/>
                  </a:ext>
                </a:extLst>
              </a:tr>
              <a:tr h="27368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Diabetes cohort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142 (8.5)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140 (11.3)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131 (6.2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P=0.00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0840292"/>
                  </a:ext>
                </a:extLst>
              </a:tr>
              <a:tr h="41973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Nondiabetic controls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144 (8.5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146 (9.6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142 (12.5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p=0.66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6755975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B904BBC8-0F28-03F0-41EE-2FC44080AA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4624686"/>
              </p:ext>
            </p:extLst>
          </p:nvPr>
        </p:nvGraphicFramePr>
        <p:xfrm>
          <a:off x="187763" y="3353914"/>
          <a:ext cx="5308600" cy="142843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63625">
                  <a:extLst>
                    <a:ext uri="{9D8B030D-6E8A-4147-A177-3AD203B41FA5}">
                      <a16:colId xmlns:a16="http://schemas.microsoft.com/office/drawing/2014/main" val="3146908369"/>
                    </a:ext>
                  </a:extLst>
                </a:gridCol>
                <a:gridCol w="1059815">
                  <a:extLst>
                    <a:ext uri="{9D8B030D-6E8A-4147-A177-3AD203B41FA5}">
                      <a16:colId xmlns:a16="http://schemas.microsoft.com/office/drawing/2014/main" val="1097697095"/>
                    </a:ext>
                  </a:extLst>
                </a:gridCol>
                <a:gridCol w="1127760">
                  <a:extLst>
                    <a:ext uri="{9D8B030D-6E8A-4147-A177-3AD203B41FA5}">
                      <a16:colId xmlns:a16="http://schemas.microsoft.com/office/drawing/2014/main" val="2819811712"/>
                    </a:ext>
                  </a:extLst>
                </a:gridCol>
                <a:gridCol w="993140">
                  <a:extLst>
                    <a:ext uri="{9D8B030D-6E8A-4147-A177-3AD203B41FA5}">
                      <a16:colId xmlns:a16="http://schemas.microsoft.com/office/drawing/2014/main" val="488731276"/>
                    </a:ext>
                  </a:extLst>
                </a:gridCol>
                <a:gridCol w="1064260">
                  <a:extLst>
                    <a:ext uri="{9D8B030D-6E8A-4147-A177-3AD203B41FA5}">
                      <a16:colId xmlns:a16="http://schemas.microsoft.com/office/drawing/2014/main" val="1745825598"/>
                    </a:ext>
                  </a:extLst>
                </a:gridCol>
              </a:tblGrid>
              <a:tr h="4413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Low Terti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00" dirty="0">
                          <a:effectLst/>
                        </a:rPr>
                        <a:t>(mmH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Medium Terti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00" dirty="0">
                          <a:effectLst/>
                        </a:rPr>
                        <a:t>(mmH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</a:rPr>
                        <a:t>High Terti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00" dirty="0">
                          <a:effectLst/>
                        </a:rPr>
                        <a:t>(mmH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Low vs High comparison 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9876169"/>
                  </a:ext>
                </a:extLst>
              </a:tr>
              <a:tr h="41973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Diabetes cohort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26.7 (1.6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27.3 (1.4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28.3 (1.5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US" sz="1100" kern="100">
                          <a:effectLst/>
                          <a:latin typeface="Calibri"/>
                          <a:cs typeface="Times New Roman"/>
                        </a:rPr>
                        <a:t>P=0.00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49713283"/>
                  </a:ext>
                </a:extLst>
              </a:tr>
              <a:tr h="41973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Nondiabetic controls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26.9 (1.2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27.4 (1.9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</a:rPr>
                        <a:t>27.7 (2.0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US" sz="1100" kern="100" dirty="0">
                          <a:effectLst/>
                          <a:latin typeface="Calibri"/>
                          <a:cs typeface="Times New Roman"/>
                        </a:rPr>
                        <a:t>P=0.09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56484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21750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cf6485-626e-4e55-ad9f-1b0cda0195f2">
      <Terms xmlns="http://schemas.microsoft.com/office/infopath/2007/PartnerControls"/>
    </lcf76f155ced4ddcb4097134ff3c332f>
    <SharedWithUsers xmlns="6843f238-49ef-47a5-b92d-07cf594071bb">
      <UserInfo>
        <DisplayName>Wilkins, Kenneth (NIH/NIDDK) [E]</DisplayName>
        <AccountId>8</AccountId>
        <AccountType/>
      </UserInfo>
      <UserInfo>
        <DisplayName>Levine, Mark (NIH/NIDDK) [E]</DisplayName>
        <AccountId>9</AccountId>
        <AccountType/>
      </UserInfo>
      <UserInfo>
        <DisplayName>Violet, Pierre-Christian (NIH/NIDDK) [E]</DisplayName>
        <AccountId>6</AccountId>
        <AccountType/>
      </UserInfo>
    </SharedWithUsers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5275A6B38B3E543BA45B3819D67B9A5" ma:contentTypeVersion="12" ma:contentTypeDescription="Create a new document." ma:contentTypeScope="" ma:versionID="cb458b0b655ce789d8e32c3915af9279">
  <xsd:schema xmlns:xsd="http://www.w3.org/2001/XMLSchema" xmlns:xs="http://www.w3.org/2001/XMLSchema" xmlns:p="http://schemas.microsoft.com/office/2006/metadata/properties" xmlns:ns2="97cf6485-626e-4e55-ad9f-1b0cda0195f2" xmlns:ns3="6843f238-49ef-47a5-b92d-07cf594071bb" targetNamespace="http://schemas.microsoft.com/office/2006/metadata/properties" ma:root="true" ma:fieldsID="508f743fa7ba6ad8da93af84df219ab7" ns2:_="" ns3:_="">
    <xsd:import namespace="97cf6485-626e-4e55-ad9f-1b0cda0195f2"/>
    <xsd:import namespace="6843f238-49ef-47a5-b92d-07cf594071b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cf6485-626e-4e55-ad9f-1b0cda0195f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8ce9f98e-9ad5-43de-b59a-72d7e946aae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6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843f238-49ef-47a5-b92d-07cf594071bb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76B1957-0A2C-494E-8EF8-A862E87B4007}">
  <ds:schemaRefs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97cf6485-626e-4e55-ad9f-1b0cda0195f2"/>
    <ds:schemaRef ds:uri="http://schemas.microsoft.com/office/2006/documentManagement/types"/>
    <ds:schemaRef ds:uri="http://schemas.microsoft.com/office/infopath/2007/PartnerControls"/>
    <ds:schemaRef ds:uri="6843f238-49ef-47a5-b92d-07cf594071bb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2FB8052C-663E-4D18-9168-48AA7E5DCFF4}">
  <ds:schemaRefs>
    <ds:schemaRef ds:uri="6843f238-49ef-47a5-b92d-07cf594071bb"/>
    <ds:schemaRef ds:uri="97cf6485-626e-4e55-ad9f-1b0cda0195f2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F165D9B3-1C36-46EE-A868-764B80E5B822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145</TotalTime>
  <Words>875</Words>
  <Application>Microsoft Office PowerPoint</Application>
  <PresentationFormat>Widescreen</PresentationFormat>
  <Paragraphs>143</Paragraphs>
  <Slides>6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Segoe UI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benuwa, Ifechukwude (NIH/NIDDK) [E]</dc:creator>
  <cp:lastModifiedBy>Ebenuwa, Ifechukwude (NIH/NIDDK) [E]</cp:lastModifiedBy>
  <cp:revision>5</cp:revision>
  <cp:lastPrinted>2024-03-12T13:22:58Z</cp:lastPrinted>
  <dcterms:created xsi:type="dcterms:W3CDTF">2023-12-21T17:32:24Z</dcterms:created>
  <dcterms:modified xsi:type="dcterms:W3CDTF">2024-09-20T22:01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5275A6B38B3E543BA45B3819D67B9A5</vt:lpwstr>
  </property>
  <property fmtid="{D5CDD505-2E9C-101B-9397-08002B2CF9AE}" pid="3" name="MediaServiceImageTags">
    <vt:lpwstr/>
  </property>
  <property fmtid="{D5CDD505-2E9C-101B-9397-08002B2CF9AE}" pid="4" name="Order">
    <vt:r8>15400</vt:r8>
  </property>
  <property fmtid="{D5CDD505-2E9C-101B-9397-08002B2CF9AE}" pid="5" name="xd_Signature">
    <vt:bool>false</vt:bool>
  </property>
  <property fmtid="{D5CDD505-2E9C-101B-9397-08002B2CF9AE}" pid="6" name="SharedWithUsers">
    <vt:lpwstr>8;#Wilkins, Kenneth (NIH/NIDDK) [E];#9;#Levine, Mark (NIH/NIDDK) [E];#6;#Violet, Pierre-Christian (NIH/NIDDK) [E]</vt:lpwstr>
  </property>
  <property fmtid="{D5CDD505-2E9C-101B-9397-08002B2CF9AE}" pid="7" name="xd_ProgID">
    <vt:lpwstr/>
  </property>
  <property fmtid="{D5CDD505-2E9C-101B-9397-08002B2CF9AE}" pid="8" name="ComplianceAssetId">
    <vt:lpwstr/>
  </property>
  <property fmtid="{D5CDD505-2E9C-101B-9397-08002B2CF9AE}" pid="9" name="TemplateUrl">
    <vt:lpwstr/>
  </property>
  <property fmtid="{D5CDD505-2E9C-101B-9397-08002B2CF9AE}" pid="10" name="_ExtendedDescription">
    <vt:lpwstr/>
  </property>
  <property fmtid="{D5CDD505-2E9C-101B-9397-08002B2CF9AE}" pid="11" name="TriggerFlowInfo">
    <vt:lpwstr/>
  </property>
</Properties>
</file>